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13B56-2FF7-483F-B9FA-730CEF64AD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C6A2F-5E59-46E7-9DCB-62C4258D03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4FA3D-2C6D-4FB6-AB44-D888CED228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81B7E-2716-45C6-8AB9-FE2402C10E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FB687-4D1D-43A8-9C41-717144EB67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E6745-17C2-4FF8-8802-3C61B0F5C4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2A54A-FAB1-430B-96C1-005F62CBB4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B16B8-FC75-4D83-9533-CF3CB0055C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94AC9-8D58-49D2-91E0-9FA92EA6DA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40040-F50D-449B-9658-E3BBD694D5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15065-7F29-4D78-ACE8-AC4B6E689F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D64A01-D33D-4A34-910B-9D85AB9A05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2B934C1-2174-4764-924E-21B07725DA12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9B6CB2E-4243-4E36-AF90-4C1F6A09C0F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4"/>
          <p:cNvSpPr/>
          <p:nvPr/>
        </p:nvSpPr>
        <p:spPr>
          <a:xfrm>
            <a:off x="168120" y="60480"/>
            <a:ext cx="6178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Table S2 :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Oligonucleotide primer sequences used to analyse the expression of gen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68120" y="851040"/>
          <a:ext cx="6473880" cy="3336840"/>
        </p:xfrm>
        <a:graphic>
          <a:graphicData uri="http://schemas.openxmlformats.org/drawingml/2006/table">
            <a:tbl>
              <a:tblPr/>
              <a:tblGrid>
                <a:gridCol w="2159280"/>
                <a:gridCol w="2157120"/>
                <a:gridCol w="2157480"/>
              </a:tblGrid>
              <a:tr h="37116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3700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-miR-15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GTGATAGGGGTTTTTACCTCG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CTAACATGTAGGAGTCAGTCC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7152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i-miR-15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GCGCAAACCAGGAAGGG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AGCCCACAGCAAGCCTC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6972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act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CATCCTGACCCTCAAG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ACGGAGCTCGTTGTA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7152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2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AGAAGATGGAAAGCA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CCCATTCTTCAGCAAA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152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ET 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CCCTGCGAGTCACAG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CGATCACCTCTGTTGT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700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JARID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CTCAGGACGAGGAGGAT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TGTGAACATGCTTGTGG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116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P53INP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ACTGTGGGACTGAGGA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GCGAGAGCTGCAACAT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700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-Ju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GTTTTGAGGCGAGACTG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TGTTTCCCTCTCGCAA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7T17:22:38Z</dcterms:created>
  <dc:creator>Sandra Pineau</dc:creator>
  <dc:description/>
  <dc:language>en-US</dc:language>
  <cp:lastModifiedBy>Sandra Pineau</cp:lastModifiedBy>
  <dcterms:modified xsi:type="dcterms:W3CDTF">2013-02-07T17:24:37Z</dcterms:modified>
  <cp:revision>1</cp:revision>
  <dc:subject/>
  <dc:title>Diapositive 1</dc:title>
</cp:coreProperties>
</file>